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7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05" autoAdjust="0"/>
    <p:restoredTop sz="94660"/>
  </p:normalViewPr>
  <p:slideViewPr>
    <p:cSldViewPr snapToGrid="0">
      <p:cViewPr varScale="1">
        <p:scale>
          <a:sx n="69" d="100"/>
          <a:sy n="69" d="100"/>
        </p:scale>
        <p:origin x="24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F2912-6A67-4913-9B89-415456E0F93E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C80A9-FAEA-4751-98D1-C075D12516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3357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619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02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765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01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333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303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765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910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090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833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80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2974245"/>
              </p:ext>
            </p:extLst>
          </p:nvPr>
        </p:nvGraphicFramePr>
        <p:xfrm>
          <a:off x="1107989" y="1622323"/>
          <a:ext cx="4276090" cy="439597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50215"/>
                <a:gridCol w="450215"/>
                <a:gridCol w="539750"/>
                <a:gridCol w="540385"/>
                <a:gridCol w="449580"/>
                <a:gridCol w="495300"/>
                <a:gridCol w="450215"/>
                <a:gridCol w="450215"/>
                <a:gridCol w="450215"/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0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3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43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54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68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95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40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65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70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75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78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79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0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1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4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5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6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7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8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89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0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1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3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4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5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6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197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W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S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F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L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K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F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M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K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F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M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K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F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M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L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K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F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M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L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K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F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M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L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V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I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Courier New" panose="02070309020205020404" pitchFamily="49" charset="0"/>
                        </a:rPr>
                        <a:t>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V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Q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A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S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F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Courier New" panose="02070309020205020404" pitchFamily="49" charset="0"/>
                        </a:rPr>
                        <a:t>-</a:t>
                      </a:r>
                      <a:endParaRPr lang="en-AU" sz="9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934908"/>
              </p:ext>
            </p:extLst>
          </p:nvPr>
        </p:nvGraphicFramePr>
        <p:xfrm>
          <a:off x="1055166" y="1305464"/>
          <a:ext cx="5047615" cy="2870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50215"/>
                <a:gridCol w="450215"/>
                <a:gridCol w="539750"/>
                <a:gridCol w="540385"/>
                <a:gridCol w="449580"/>
                <a:gridCol w="428625"/>
                <a:gridCol w="450215"/>
                <a:gridCol w="450215"/>
                <a:gridCol w="450215"/>
                <a:gridCol w="838200"/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a.a. posn.</a:t>
                      </a:r>
                      <a:endParaRPr lang="en-AU" sz="9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 dirty="0">
                          <a:solidFill>
                            <a:schemeClr val="tx1"/>
                          </a:solidFill>
                          <a:effectLst/>
                        </a:rPr>
                        <a:t>BdTr10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 dirty="0">
                          <a:solidFill>
                            <a:schemeClr val="tx1"/>
                          </a:solidFill>
                          <a:effectLst/>
                        </a:rPr>
                        <a:t>Yrr1</a:t>
                      </a:r>
                      <a:endParaRPr lang="en-AU" sz="9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 dirty="0">
                          <a:solidFill>
                            <a:schemeClr val="tx1"/>
                          </a:solidFill>
                          <a:effectLst/>
                        </a:rPr>
                        <a:t>BdTr13k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 dirty="0">
                          <a:solidFill>
                            <a:schemeClr val="tx1"/>
                          </a:solidFill>
                          <a:effectLst/>
                        </a:rPr>
                        <a:t>Yrr1</a:t>
                      </a:r>
                      <a:endParaRPr lang="en-AU" sz="9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ABR6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Yrr1</a:t>
                      </a:r>
                      <a:endParaRPr lang="en-AU" sz="9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Bd21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yrr1</a:t>
                      </a:r>
                      <a:endParaRPr lang="en-AU" sz="9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Tek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yrr1</a:t>
                      </a:r>
                      <a:endParaRPr lang="en-AU" sz="9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Tek4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yrr1</a:t>
                      </a:r>
                      <a:endParaRPr lang="en-AU" sz="9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Luc1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900" b="1">
                          <a:solidFill>
                            <a:schemeClr val="tx1"/>
                          </a:solidFill>
                          <a:effectLst/>
                        </a:rPr>
                        <a:t>yrr1</a:t>
                      </a:r>
                      <a:endParaRPr lang="en-AU" sz="900" b="1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AU" sz="9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</a:tbl>
          </a:graphicData>
        </a:graphic>
      </p:graphicFrame>
      <p:cxnSp>
        <p:nvCxnSpPr>
          <p:cNvPr id="8" name="Straight Connector 7"/>
          <p:cNvCxnSpPr/>
          <p:nvPr/>
        </p:nvCxnSpPr>
        <p:spPr>
          <a:xfrm>
            <a:off x="1330989" y="1605826"/>
            <a:ext cx="3924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639980" y="11391682"/>
            <a:ext cx="38779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 smtClean="0"/>
              <a:t>Figure S4</a:t>
            </a:r>
            <a:r>
              <a:rPr lang="en-AU" sz="1200" dirty="0" smtClean="0"/>
              <a:t>: Comparison of Bradi4g24315 proteins 	</a:t>
            </a:r>
            <a:endParaRPr lang="en-AU" sz="1200" dirty="0"/>
          </a:p>
        </p:txBody>
      </p:sp>
      <p:sp>
        <p:nvSpPr>
          <p:cNvPr id="10" name="Rectangle 9"/>
          <p:cNvSpPr/>
          <p:nvPr/>
        </p:nvSpPr>
        <p:spPr>
          <a:xfrm>
            <a:off x="332394" y="344288"/>
            <a:ext cx="23193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/>
              <a:t>Supplemental Figure 4</a:t>
            </a:r>
            <a:endParaRPr lang="en-AU" dirty="0"/>
          </a:p>
        </p:txBody>
      </p:sp>
      <p:sp>
        <p:nvSpPr>
          <p:cNvPr id="2" name="Rectangle 1"/>
          <p:cNvSpPr/>
          <p:nvPr/>
        </p:nvSpPr>
        <p:spPr>
          <a:xfrm>
            <a:off x="1055166" y="6424335"/>
            <a:ext cx="5836727" cy="46998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uc1      MLQAPSVKMRRGLLRYMIERFDTSSKKFVIEKSEYGSISLDHRDVTSILGLVNTGLSVAD	6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2      MLQAPSVKMRRGLLRYMIERFDTSSKKFVIEKSEYGSISLDHRDVTSILGLVNTGLSVAD	6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3k       MLQAPSVKMRRGLLRYMIERFDTSSKKFVIEKSEYGSISLDHRDVTSILGLVNTGLSVAD	6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4      MLQAPSVKMRRGLLRYMIERFDTSSKKFVIEKSEYGSISLDHRDVTSILGLVNTGLSVAD	6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0h       MLQAPSVKMRRGVLRYMIERFDTSSKKFVIEKSEYGSISLDHWDVTSILGLVNIGLSVAD	6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d21      MLQAPSVKMHRGVLRYMIERFDTSSKKFVIEKSEYGSISLDHRDVTSILGLVNIGLSVAD	6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BR6      MLQAPSVKMRRGVLRYMIERFDTSSKKFVIEKSEYGSISLDHRDVTSILGLVNIGLSVAD	6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*********:**:***************************** ********** ******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uc1      VLIEEGLDVRDRIPSRFVSRQTHNLVIDQLIEDTVRDGTGDDDFLRRSVLVLIGVLLAPD	12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2      VLIEEGLDVRDRIPSRFVSRQTHNLVIDQLIEDTVRDGTGDDDFLRRSVLVLIGVLLAPD	12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3k       VLIEEGLDVRDRIPSRFVSRQTHNLVIDQLIEDTVRDGTGDDDFLRRSVLVLIGVLLAPD	12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4      VLIEEGLDVRDRIPSRFVSRQTHNLVIDQLIEDTVRDGTGDDDFLRRSVLVLIGVLLAPD	12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0h       VLIEEGLHVRDRIPSRFVSRQTHNLVIDQLIEDTVRDGTGDDDFLRRSVLVLIGVLLAPD	12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d21      VLIEEGLHVRDRIPSRFVSRQTHNLVIDQLIEDTIRDGTGDDDFLRRSVLVLIGVLLAPD	12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BR6      VLIEEGLHVRDRIPSRFVSRQTHNLVIDQLIEDTVRDGTGDDDFLRRSVLVLIGVLLAPD	12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*******.**************************:*************************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uc1      NGLIVPKEYFALVEDIKRMRLFNWNAFTLSILFDGLGKVKKGDSIIQWPRGNLALIQVQA	18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2      NGLIVPKEYFALVEDIKRMRLFNWNAFTLSILFDGLGKVKKGDSIIQWPRGNLAPIQYKP	18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3k       NGLIVPKEYFALVEDIKRMRLFNWNAFTLSILFDGLGKVKKGDSIIQWPRGNLALIQYKP	18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4      NGLIVPKEYFALVEDIKRMRLFNWNAFTLSILFDGLGKVKKGDSIIQWPRGNLALIQYKP	18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0h       NGLIVPKEYFALVEDIKRMRLFNWNAFTLSILFDGLGKVKKGDSVIQWPQGNLAPIQYSR	18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d21      NGLIVPKEYFALVEDIKRMCLFNWNAFTLSILFDGLGKVKKGDSVIQWPQGNLAPIQYKP	18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BR6      NGLIVPKEYFALVEDIKRMRLFNWNAFTLSILFDGLGKVKKGDSVIQWPQGNLAPIQYKP	180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******************* ************************:****:**** ** . 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uc1      DYFSFRIY-</a:t>
            </a:r>
            <a:r>
              <a:rPr lang="en-AU" sz="8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</a:t>
            </a: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</a:t>
            </a:r>
            <a:r>
              <a:rPr lang="en-AU" sz="8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88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2      TIFHLEFIYICILQLHM-----	197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3k       TIFHLEFIYICILQLHM-----	197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ek4      TIFHLEFIYICILQLRM-----	197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0h       LFFI------------------	184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d21      TIFHLEFIYICILQLHM*----	197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BR6      TIFHLEFIYICILQLHM-----	197</a:t>
            </a:r>
            <a:endParaRPr lang="en-AU" sz="8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*                   </a:t>
            </a:r>
            <a:endParaRPr lang="en-AU" sz="8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9162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90</TotalTime>
  <Words>262</Words>
  <Application>Microsoft Office PowerPoint</Application>
  <PresentationFormat>Widescreen</PresentationFormat>
  <Paragraphs>28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griculture, Crace)</dc:creator>
  <cp:lastModifiedBy>Ayliffe, Michael (Agriculture, Crace)</cp:lastModifiedBy>
  <cp:revision>447</cp:revision>
  <cp:lastPrinted>2018-08-23T00:28:01Z</cp:lastPrinted>
  <dcterms:created xsi:type="dcterms:W3CDTF">2016-09-08T23:56:59Z</dcterms:created>
  <dcterms:modified xsi:type="dcterms:W3CDTF">2018-08-23T00:38:23Z</dcterms:modified>
</cp:coreProperties>
</file>